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04"/>
  </p:normalViewPr>
  <p:slideViewPr>
    <p:cSldViewPr snapToGrid="0" snapToObjects="1">
      <p:cViewPr varScale="1">
        <p:scale>
          <a:sx n="95" d="100"/>
          <a:sy n="95" d="100"/>
        </p:scale>
        <p:origin x="-728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hasegawakouhei\Documents\&#23398;&#20250;&#12539;&#33258;&#20316;&#35542;&#25991;&#12539;&#38609;&#35468;&#21407;&#31295;\&#35542;&#25991;\E.%20tarda\Table%20and%20Figure.xlsx" TargetMode="External"/><Relationship Id="rId2" Type="http://schemas.microsoft.com/office/2011/relationships/chartStyle" Target="style1.xml"/><Relationship Id="rId3" Type="http://schemas.microsoft.com/office/2011/relationships/chartColorStyle" Target="colors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573896595208071"/>
          <c:y val="0.0398206683494707"/>
          <c:w val="0.928738965952081"/>
          <c:h val="0.9077391402629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, seasonal tendency'!$B$1</c:f>
              <c:strCache>
                <c:ptCount val="1"/>
                <c:pt idx="0">
                  <c:v>Case numbe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Figure, seasonal tendency'!$A$2:$A$13</c:f>
              <c:strCache>
                <c:ptCount val="12"/>
                <c:pt idx="0">
                  <c:v>January</c:v>
                </c:pt>
                <c:pt idx="1">
                  <c:v>February</c:v>
                </c:pt>
                <c:pt idx="2">
                  <c:v>March</c:v>
                </c:pt>
                <c:pt idx="3">
                  <c:v>April</c:v>
                </c:pt>
                <c:pt idx="4">
                  <c:v>May</c:v>
                </c:pt>
                <c:pt idx="5">
                  <c:v>June</c:v>
                </c:pt>
                <c:pt idx="6">
                  <c:v>July</c:v>
                </c:pt>
                <c:pt idx="7">
                  <c:v>August</c:v>
                </c:pt>
                <c:pt idx="8">
                  <c:v>September</c:v>
                </c:pt>
                <c:pt idx="9">
                  <c:v>October</c:v>
                </c:pt>
                <c:pt idx="10">
                  <c:v>November</c:v>
                </c:pt>
                <c:pt idx="11">
                  <c:v>December</c:v>
                </c:pt>
              </c:strCache>
            </c:strRef>
          </c:cat>
          <c:val>
            <c:numRef>
              <c:f>'Figure, seasonal tendency'!$B$2:$B$13</c:f>
              <c:numCache>
                <c:formatCode>General</c:formatCode>
                <c:ptCount val="12"/>
                <c:pt idx="0">
                  <c:v>2.0</c:v>
                </c:pt>
                <c:pt idx="1">
                  <c:v>2.0</c:v>
                </c:pt>
                <c:pt idx="2">
                  <c:v>4.0</c:v>
                </c:pt>
                <c:pt idx="3">
                  <c:v>2.0</c:v>
                </c:pt>
                <c:pt idx="4">
                  <c:v>3.0</c:v>
                </c:pt>
                <c:pt idx="5">
                  <c:v>3.0</c:v>
                </c:pt>
                <c:pt idx="6">
                  <c:v>3.0</c:v>
                </c:pt>
                <c:pt idx="7">
                  <c:v>4.0</c:v>
                </c:pt>
                <c:pt idx="8">
                  <c:v>5.0</c:v>
                </c:pt>
                <c:pt idx="9">
                  <c:v>2.0</c:v>
                </c:pt>
                <c:pt idx="10">
                  <c:v>5.0</c:v>
                </c:pt>
                <c:pt idx="11">
                  <c:v>3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783-F445-9201-C22214462F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0925624"/>
        <c:axId val="2103669400"/>
      </c:barChart>
      <c:catAx>
        <c:axId val="2130925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03669400"/>
        <c:crosses val="autoZero"/>
        <c:auto val="1"/>
        <c:lblAlgn val="ctr"/>
        <c:lblOffset val="100"/>
        <c:noMultiLvlLbl val="0"/>
      </c:catAx>
      <c:valAx>
        <c:axId val="2103669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Case number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30925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4F1D7B8-F828-004B-B909-766035AD30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129F47CC-2DCD-8C43-B4A5-00921E3A8F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63ECC4A2-FBAD-514A-BD15-B27C26BC9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42AB43D-4FCD-2E46-85E3-C2CDF4470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C67D25EB-2B27-994E-B861-C76FA9700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51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27E07F0-1087-AA4C-B3A7-0EAB0BCAB3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A41B998C-13B7-2F46-AF10-1B1233EE04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D6C67F0-5D0A-E240-8F26-1E060F7EC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BEACFF22-DE08-B54F-BBAC-515489F1C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134F444-3DEF-5542-A624-5A921A555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8992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FF5B52E0-FFC8-AB40-9CE7-45DD333DB2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D2912AC5-FB36-1A46-899B-45AE890B50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9C0225C-0ADC-E746-9BA1-3C230D2F4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67CF96B-7964-4E49-B950-209ED3576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FC2405B-FB83-D84B-9039-FAB9FDDAE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5138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1C5D505-641A-A34F-A2AF-A2CBEF83C9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2A9A73D0-517D-F44B-BCAE-E24A5AAE25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9332DA0-2AB1-0D49-BF69-FEB12DA74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DCEF0567-2A7B-E445-BE78-9A0DF93AE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D1286EB5-B8B9-7540-88AF-605565139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02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0A9CA8D-B391-E240-B7EA-8E752B80F5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A492A857-AA19-4145-8D7C-D28900A407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99E34ACC-DE8D-B940-8DBC-D426DFC6F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BE987530-B6AD-5A44-BAF3-5308CF741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DE44CE50-A60E-2A4D-88D5-C9E9F8A5B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3163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3ED61AC-B8F1-9E42-BDF1-544E2470AF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4DE563D1-6A67-0A47-8F3F-608F565B68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8BB77B90-D12A-9844-92DE-ADB5ABBD97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9967575B-4C43-5D41-B45E-55EE0E426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E262E884-33CF-6E44-8DA8-8C35E6EA5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19B46E69-64AF-754A-B471-0C0DFEF23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4051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56CA5FC-230C-B047-AD60-EE77700849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AD4BE086-DCAD-DB49-A45A-86A9FEDC2C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18089EAD-AB51-6047-B00B-E2247C7331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A42AFE5E-0C06-184B-808A-296BBD04B8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3F8667D4-E675-B945-B931-C8FF4A6DB9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599AD989-56BD-E446-98CD-F4B5DB82C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1226A1D8-70C9-8943-B664-3553D7F83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A7BCE75D-14E8-5544-9B6E-A848993B9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3606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7EFE7F3-8FD4-3B4B-9C24-72F50B8760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54BED685-0F54-3F4D-907C-AC48BA1E44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189F0304-953E-BA40-AC51-5604C0573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A25ACA2C-C9C7-BF48-9911-EE2443912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82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3F33C9C2-EEE3-434B-A903-961C2F49B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6C96883C-271B-5547-A08C-31B027D9A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A65A3D70-390A-754A-BCFC-3A8211467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3771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7314C90-ED73-014C-B1EC-50D270A2D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CF0DCA5B-DF67-ED46-BE0F-3DE4AD7A6C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85D34494-9AEA-D441-8BCD-5E2F9DC6DD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42A8ED7E-C521-1A4C-A746-EC5974447E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7876EDCE-60F3-5A44-8D8A-B10133A08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9609CC8A-26AD-264E-A96E-2DDA0DCD9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829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7637575-30BA-2848-9F87-2AA3A0B9D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437E19DB-3C14-A445-AAB9-896D0F9365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7A496E02-2D58-AD4C-B31E-0EA30039EE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4039B390-5A19-7942-B9F6-A1CC8147B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EFB62BCC-1730-DD4B-9775-B7D7C599E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7BC6F6B7-DD91-B144-9A00-C1CFD0F2B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262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CA226D62-5F7A-0348-9358-0F461F117C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4C9E1ADA-D291-5D47-B24B-023D6DC417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AA584B0-5153-2B40-B33F-7655C04DE6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EC739-159D-E744-A13A-4647C2F433D5}" type="datetimeFigureOut">
              <a:rPr kumimoji="1" lang="ja-JP" altLang="en-US" smtClean="0"/>
              <a:t>03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26FBDD66-2268-5D4E-A6D8-3B65DE73CC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5E4840C-AFDA-2044-87E6-C1C42C20E2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421C32-412F-7E44-B025-393AE79A3E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9091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D717A3FB-CC5C-C441-A017-0AF613B3F3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5758349"/>
              </p:ext>
            </p:extLst>
          </p:nvPr>
        </p:nvGraphicFramePr>
        <p:xfrm>
          <a:off x="1060450" y="774700"/>
          <a:ext cx="10071100" cy="5308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49416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長谷川 耕平</dc:creator>
  <cp:lastModifiedBy>Author  </cp:lastModifiedBy>
  <cp:revision>1</cp:revision>
  <dcterms:created xsi:type="dcterms:W3CDTF">2022-08-17T03:11:28Z</dcterms:created>
  <dcterms:modified xsi:type="dcterms:W3CDTF">2022-11-03T06:50:08Z</dcterms:modified>
</cp:coreProperties>
</file>